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7B4F17-A543-434D-B0E8-578F168AB2D8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A3A287-0070-4108-8B8E-19CC91F54963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0C487-8838-44D1-8C9E-635BD224EA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6CF2B-E838-494D-BBD9-F8393A8A40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39E70-3444-415F-86AF-30125D443D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2FC6B-4982-469A-995F-D464FE8DAE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BB4809-86C4-4081-8E72-7AC74F8E91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FF3A6-26FF-40F4-A66D-5B7C9DEEE2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38A3C-9EC0-46E1-80DC-B6F2DB2470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B250F0-1B87-4D5B-BD71-D8402D56A6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CA8233-3D2A-4424-925A-E848D8DAAB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1F0A4-6142-46E9-BD1D-9A76F4376E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9404DF-BDAC-4E9A-9131-45CF171CEC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B93B11-8A0E-4D60-8EC4-10CB8E0617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A7987D-99CB-41B9-8B2A-B1A3371725D9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187280" y="1413000"/>
          <a:ext cx="6012000" cy="4073400"/>
        </p:xfrm>
        <a:graphic>
          <a:graphicData uri="http://schemas.openxmlformats.org/drawingml/2006/table">
            <a:tbl>
              <a:tblPr/>
              <a:tblGrid>
                <a:gridCol w="1149480"/>
                <a:gridCol w="843120"/>
                <a:gridCol w="573120"/>
                <a:gridCol w="574560"/>
                <a:gridCol w="574560"/>
                <a:gridCol w="574920"/>
                <a:gridCol w="574560"/>
                <a:gridCol w="574560"/>
                <a:gridCol w="573120"/>
              </a:tblGrid>
              <a:tr h="398160">
                <a:tc row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r>
                        <a:rPr b="0" lang="fr-FR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</a:t>
                      </a: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experim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gridSpan="7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ermidine (mM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87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06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r>
                        <a:rPr b="0" lang="fr-FR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</a:t>
                      </a: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seri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tr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 (°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</a:t>
                      </a: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 (°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3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mp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 (°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</a:t>
                      </a: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 (°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8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2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3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3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06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06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r>
                        <a:rPr b="0" lang="fr-FR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d</a:t>
                      </a: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seri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tr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 (°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</a:t>
                      </a: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 (°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0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8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0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8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mp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 (°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</a:t>
                      </a: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m (°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0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0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7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8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0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8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1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57200">
                <a:tc gridSpan="9">
                  <a:txBody>
                    <a:bodyPr lIns="90000" rIns="90000" tIns="46800" bIns="468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breviations: Tm (°C), Temperature melting (in degrees Celsius); NA, non amplification; NA, non amplification (complete inhibition)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13T07:59:52Z</dcterms:created>
  <dc:creator>jp roperch</dc:creator>
  <dc:description/>
  <dc:language>en-US</dc:language>
  <cp:lastModifiedBy>Jean-pierre ROPERCH</cp:lastModifiedBy>
  <dcterms:modified xsi:type="dcterms:W3CDTF">2014-09-17T16:26:20Z</dcterms:modified>
  <cp:revision>43</cp:revision>
  <dc:subject/>
  <dc:title>Diapositive 1</dc:title>
</cp:coreProperties>
</file>